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41148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A3347-69E0-4922-84F8-FEF91485CD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8800" y="960120"/>
            <a:ext cx="699480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8800" y="2378520"/>
            <a:ext cx="699480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52887-44E6-4945-89ED-AE1E5E3E7B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8800" y="9601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72960" y="9601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8800" y="23785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72960" y="23785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5FADA-A789-4407-B65C-2AE7CB9FC9A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8800" y="960120"/>
            <a:ext cx="2252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54000" y="960120"/>
            <a:ext cx="2252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19200" y="960120"/>
            <a:ext cx="2252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8800" y="2378520"/>
            <a:ext cx="2252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54000" y="2378520"/>
            <a:ext cx="2252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19200" y="2378520"/>
            <a:ext cx="2252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D1BBA-612A-4EE7-A842-DBB7494D77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8800" y="960120"/>
            <a:ext cx="6994800" cy="271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077984-0298-4441-B449-F4392FC12E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8800" y="960120"/>
            <a:ext cx="6994800" cy="271476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4F1257-DC05-4D38-BD15-2755C4EB8D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8800" y="960120"/>
            <a:ext cx="3413160" cy="271476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72960" y="960120"/>
            <a:ext cx="3413160" cy="271476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DD527-DD2C-4335-B6EB-C6190032D1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B5D86-8D28-48F8-AC75-F31969FD3C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8800" y="164880"/>
            <a:ext cx="6994800" cy="3180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689C2-0A47-4327-8296-73FD031A61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800" y="9601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2960" y="960120"/>
            <a:ext cx="3413160" cy="271476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8800" y="23785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7AB6B-5EC9-4864-849F-C8A28B3073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800" y="960120"/>
            <a:ext cx="3413160" cy="271476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2960" y="9601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72960" y="23785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83E86-7905-4634-8F9B-D73425CD7A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800" y="9601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72960" y="960120"/>
            <a:ext cx="341316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8800" y="2378520"/>
            <a:ext cx="6994800" cy="129492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491D4F-649D-41AE-97ED-4B08384538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8800" y="164880"/>
            <a:ext cx="6994800" cy="68580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ctr">
            <a:noAutofit/>
          </a:bodyPr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8800" y="960120"/>
            <a:ext cx="6994800" cy="271476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rmAutofit fontScale="87000"/>
          </a:bodyPr>
          <a:p>
            <a:pPr marL="221040" indent="-22104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480600" indent="-1850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738720" indent="-147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034280" indent="-1476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329840" indent="-14760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329840" indent="-14760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329840" indent="-14760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8800" y="3746520"/>
            <a:ext cx="1812960" cy="28584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Autofit/>
          </a:bodyPr>
          <a:lstStyle>
            <a:lvl1pPr indent="0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3746520"/>
            <a:ext cx="2460960" cy="28584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Autofit/>
          </a:bodyPr>
          <a:lstStyle>
            <a:lvl1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3746520"/>
            <a:ext cx="1812960" cy="285840"/>
          </a:xfrm>
          <a:prstGeom prst="rect">
            <a:avLst/>
          </a:prstGeom>
          <a:noFill/>
          <a:ln w="0">
            <a:noFill/>
          </a:ln>
        </p:spPr>
        <p:txBody>
          <a:bodyPr lIns="68040" rIns="68040" tIns="33840" bIns="33840" anchor="t">
            <a:noAutofit/>
          </a:bodyPr>
          <a:lstStyle>
            <a:lvl1pPr indent="0" algn="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fld id="{943B1043-41BB-418A-8015-02F80D7F0D7A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0" y="0"/>
            <a:ext cx="7717680" cy="4111200"/>
            <a:chOff x="0" y="0"/>
            <a:chExt cx="7717680" cy="4111200"/>
          </a:xfrm>
        </p:grpSpPr>
        <p:sp>
          <p:nvSpPr>
            <p:cNvPr id="42" name=""/>
            <p:cNvSpPr/>
            <p:nvPr/>
          </p:nvSpPr>
          <p:spPr>
            <a:xfrm>
              <a:off x="774000" y="410040"/>
              <a:ext cx="2219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y = 0.92049 - 2.0246e-5x   R^2 = 0.0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410480" y="16920"/>
              <a:ext cx="864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) 0% RS me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012640" y="329400"/>
              <a:ext cx="214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y = 1.0924 - 3.2647e-5x   R^2 = 0.1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5794920" y="0"/>
              <a:ext cx="977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) 5.4% RS me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"/>
            <p:cNvGrpSpPr/>
            <p:nvPr/>
          </p:nvGrpSpPr>
          <p:grpSpPr>
            <a:xfrm>
              <a:off x="591840" y="3537360"/>
              <a:ext cx="2794680" cy="152640"/>
              <a:chOff x="591840" y="3537360"/>
              <a:chExt cx="2794680" cy="152640"/>
            </a:xfrm>
          </p:grpSpPr>
          <p:sp>
            <p:nvSpPr>
              <p:cNvPr id="47" name=""/>
              <p:cNvSpPr/>
              <p:nvPr/>
            </p:nvSpPr>
            <p:spPr>
              <a:xfrm>
                <a:off x="3105360" y="353736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5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593440" y="353736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075040" y="353736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3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1556280" y="353736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041120" y="353736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591840" y="353736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" name=""/>
            <p:cNvGrpSpPr/>
            <p:nvPr/>
          </p:nvGrpSpPr>
          <p:grpSpPr>
            <a:xfrm>
              <a:off x="608400" y="3476880"/>
              <a:ext cx="2577960" cy="27000"/>
              <a:chOff x="608400" y="3476880"/>
              <a:chExt cx="2577960" cy="27000"/>
            </a:xfrm>
          </p:grpSpPr>
          <p:sp>
            <p:nvSpPr>
              <p:cNvPr id="54" name=""/>
              <p:cNvSpPr/>
              <p:nvPr/>
            </p:nvSpPr>
            <p:spPr>
              <a:xfrm flipV="1">
                <a:off x="608400" y="347688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V="1">
                <a:off x="869040" y="3477240"/>
                <a:ext cx="720" cy="13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V="1">
                <a:off x="1122120" y="347688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 flipV="1">
                <a:off x="1382760" y="3477240"/>
                <a:ext cx="720" cy="13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>
                <a:off x="1636200" y="347688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 flipV="1">
                <a:off x="1896840" y="3477240"/>
                <a:ext cx="720" cy="13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flipV="1">
                <a:off x="2157480" y="347688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flipV="1">
                <a:off x="2410920" y="3477240"/>
                <a:ext cx="720" cy="13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 flipV="1">
                <a:off x="2671560" y="347688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V="1">
                <a:off x="2924640" y="3477240"/>
                <a:ext cx="720" cy="13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V="1">
                <a:off x="3185640" y="347688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608400" y="3477240"/>
                <a:ext cx="25772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6" name=""/>
            <p:cNvGrpSpPr/>
            <p:nvPr/>
          </p:nvGrpSpPr>
          <p:grpSpPr>
            <a:xfrm>
              <a:off x="310680" y="494640"/>
              <a:ext cx="182520" cy="3084480"/>
              <a:chOff x="310680" y="494640"/>
              <a:chExt cx="182520" cy="3084480"/>
            </a:xfrm>
          </p:grpSpPr>
          <p:sp>
            <p:nvSpPr>
              <p:cNvPr id="67" name=""/>
              <p:cNvSpPr/>
              <p:nvPr/>
            </p:nvSpPr>
            <p:spPr>
              <a:xfrm>
                <a:off x="317160" y="34264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317160" y="28465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17160" y="22604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317160" y="16678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17160" y="107856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310680" y="4946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3" name=""/>
            <p:cNvGrpSpPr/>
            <p:nvPr/>
          </p:nvGrpSpPr>
          <p:grpSpPr>
            <a:xfrm>
              <a:off x="577440" y="541080"/>
              <a:ext cx="30960" cy="2937600"/>
              <a:chOff x="577440" y="541080"/>
              <a:chExt cx="30960" cy="2937600"/>
            </a:xfrm>
          </p:grpSpPr>
          <p:sp>
            <p:nvSpPr>
              <p:cNvPr id="74" name=""/>
              <p:cNvSpPr/>
              <p:nvPr/>
            </p:nvSpPr>
            <p:spPr>
              <a:xfrm flipH="1">
                <a:off x="577440" y="3477960"/>
                <a:ext cx="302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flipH="1">
                <a:off x="592200" y="3187440"/>
                <a:ext cx="15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H="1">
                <a:off x="577440" y="2890440"/>
                <a:ext cx="302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 flipH="1">
                <a:off x="592200" y="2593440"/>
                <a:ext cx="15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H="1">
                <a:off x="577440" y="2303280"/>
                <a:ext cx="302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H="1">
                <a:off x="592200" y="2012760"/>
                <a:ext cx="15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flipH="1">
                <a:off x="577440" y="1715760"/>
                <a:ext cx="302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H="1">
                <a:off x="592200" y="1425600"/>
                <a:ext cx="15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flipH="1">
                <a:off x="577440" y="1128240"/>
                <a:ext cx="302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 flipH="1">
                <a:off x="592200" y="838080"/>
                <a:ext cx="15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H="1">
                <a:off x="577440" y="541080"/>
                <a:ext cx="302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flipV="1">
                <a:off x="607680" y="541080"/>
                <a:ext cx="720" cy="293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6" name=""/>
            <p:cNvGrpSpPr/>
            <p:nvPr/>
          </p:nvGrpSpPr>
          <p:grpSpPr>
            <a:xfrm>
              <a:off x="794520" y="2317320"/>
              <a:ext cx="37080" cy="32400"/>
              <a:chOff x="794520" y="2317320"/>
              <a:chExt cx="37080" cy="32400"/>
            </a:xfrm>
          </p:grpSpPr>
          <p:sp>
            <p:nvSpPr>
              <p:cNvPr id="87" name=""/>
              <p:cNvSpPr/>
              <p:nvPr/>
            </p:nvSpPr>
            <p:spPr>
              <a:xfrm>
                <a:off x="794520" y="2317320"/>
                <a:ext cx="37080" cy="324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809280" y="23302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9" name=""/>
            <p:cNvGrpSpPr/>
            <p:nvPr/>
          </p:nvGrpSpPr>
          <p:grpSpPr>
            <a:xfrm>
              <a:off x="898920" y="2494440"/>
              <a:ext cx="37080" cy="34560"/>
              <a:chOff x="898920" y="2494440"/>
              <a:chExt cx="37080" cy="34560"/>
            </a:xfrm>
          </p:grpSpPr>
          <p:sp>
            <p:nvSpPr>
              <p:cNvPr id="90" name=""/>
              <p:cNvSpPr/>
              <p:nvPr/>
            </p:nvSpPr>
            <p:spPr>
              <a:xfrm>
                <a:off x="898920" y="2494440"/>
                <a:ext cx="37080" cy="3456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913680" y="25081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2" name=""/>
            <p:cNvGrpSpPr/>
            <p:nvPr/>
          </p:nvGrpSpPr>
          <p:grpSpPr>
            <a:xfrm>
              <a:off x="1120680" y="2317320"/>
              <a:ext cx="38880" cy="32400"/>
              <a:chOff x="1120680" y="2317320"/>
              <a:chExt cx="38880" cy="32400"/>
            </a:xfrm>
          </p:grpSpPr>
          <p:sp>
            <p:nvSpPr>
              <p:cNvPr id="93" name=""/>
              <p:cNvSpPr/>
              <p:nvPr/>
            </p:nvSpPr>
            <p:spPr>
              <a:xfrm>
                <a:off x="1120680" y="2317320"/>
                <a:ext cx="38880" cy="324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1136160" y="23302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5" name=""/>
            <p:cNvGrpSpPr/>
            <p:nvPr/>
          </p:nvGrpSpPr>
          <p:grpSpPr>
            <a:xfrm>
              <a:off x="1346040" y="1788120"/>
              <a:ext cx="37080" cy="34200"/>
              <a:chOff x="1346040" y="1788120"/>
              <a:chExt cx="37080" cy="34200"/>
            </a:xfrm>
          </p:grpSpPr>
          <p:sp>
            <p:nvSpPr>
              <p:cNvPr id="96" name=""/>
              <p:cNvSpPr/>
              <p:nvPr/>
            </p:nvSpPr>
            <p:spPr>
              <a:xfrm>
                <a:off x="1346040" y="1788120"/>
                <a:ext cx="37080" cy="342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360800" y="18014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8" name=""/>
            <p:cNvGrpSpPr/>
            <p:nvPr/>
          </p:nvGrpSpPr>
          <p:grpSpPr>
            <a:xfrm>
              <a:off x="1532160" y="732960"/>
              <a:ext cx="37080" cy="32400"/>
              <a:chOff x="1532160" y="732960"/>
              <a:chExt cx="37080" cy="32400"/>
            </a:xfrm>
          </p:grpSpPr>
          <p:sp>
            <p:nvSpPr>
              <p:cNvPr id="99" name=""/>
              <p:cNvSpPr/>
              <p:nvPr/>
            </p:nvSpPr>
            <p:spPr>
              <a:xfrm>
                <a:off x="1532160" y="732960"/>
                <a:ext cx="37080" cy="324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1546920" y="7459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1" name=""/>
            <p:cNvGrpSpPr/>
            <p:nvPr/>
          </p:nvGrpSpPr>
          <p:grpSpPr>
            <a:xfrm>
              <a:off x="1755720" y="1644120"/>
              <a:ext cx="37080" cy="32040"/>
              <a:chOff x="1755720" y="1644120"/>
              <a:chExt cx="37080" cy="32040"/>
            </a:xfrm>
          </p:grpSpPr>
          <p:sp>
            <p:nvSpPr>
              <p:cNvPr id="102" name=""/>
              <p:cNvSpPr/>
              <p:nvPr/>
            </p:nvSpPr>
            <p:spPr>
              <a:xfrm>
                <a:off x="1755720" y="1644120"/>
                <a:ext cx="370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1770480" y="16567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4" name=""/>
            <p:cNvGrpSpPr/>
            <p:nvPr/>
          </p:nvGrpSpPr>
          <p:grpSpPr>
            <a:xfrm>
              <a:off x="2246760" y="1525320"/>
              <a:ext cx="37440" cy="32400"/>
              <a:chOff x="2246760" y="1525320"/>
              <a:chExt cx="37440" cy="32400"/>
            </a:xfrm>
          </p:grpSpPr>
          <p:sp>
            <p:nvSpPr>
              <p:cNvPr id="105" name=""/>
              <p:cNvSpPr/>
              <p:nvPr/>
            </p:nvSpPr>
            <p:spPr>
              <a:xfrm>
                <a:off x="2246760" y="1525320"/>
                <a:ext cx="37440" cy="324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2261880" y="15379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7" name=""/>
            <p:cNvGrpSpPr/>
            <p:nvPr/>
          </p:nvGrpSpPr>
          <p:grpSpPr>
            <a:xfrm>
              <a:off x="2359080" y="3021840"/>
              <a:ext cx="37440" cy="34200"/>
              <a:chOff x="2359080" y="3021840"/>
              <a:chExt cx="37440" cy="34200"/>
            </a:xfrm>
          </p:grpSpPr>
          <p:sp>
            <p:nvSpPr>
              <p:cNvPr id="108" name=""/>
              <p:cNvSpPr/>
              <p:nvPr/>
            </p:nvSpPr>
            <p:spPr>
              <a:xfrm>
                <a:off x="2359080" y="3021840"/>
                <a:ext cx="37440" cy="342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2373840" y="30351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0" name=""/>
            <p:cNvGrpSpPr/>
            <p:nvPr/>
          </p:nvGrpSpPr>
          <p:grpSpPr>
            <a:xfrm>
              <a:off x="2827800" y="3140640"/>
              <a:ext cx="37080" cy="34200"/>
              <a:chOff x="2827800" y="3140640"/>
              <a:chExt cx="37080" cy="34200"/>
            </a:xfrm>
          </p:grpSpPr>
          <p:sp>
            <p:nvSpPr>
              <p:cNvPr id="111" name=""/>
              <p:cNvSpPr/>
              <p:nvPr/>
            </p:nvSpPr>
            <p:spPr>
              <a:xfrm>
                <a:off x="2827800" y="3140640"/>
                <a:ext cx="37080" cy="342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2842560" y="31539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3" name=""/>
            <p:cNvGrpSpPr/>
            <p:nvPr/>
          </p:nvGrpSpPr>
          <p:grpSpPr>
            <a:xfrm>
              <a:off x="3141000" y="1762560"/>
              <a:ext cx="37080" cy="32400"/>
              <a:chOff x="3141000" y="1762560"/>
              <a:chExt cx="37080" cy="32400"/>
            </a:xfrm>
          </p:grpSpPr>
          <p:sp>
            <p:nvSpPr>
              <p:cNvPr id="114" name=""/>
              <p:cNvSpPr/>
              <p:nvPr/>
            </p:nvSpPr>
            <p:spPr>
              <a:xfrm>
                <a:off x="3141000" y="1762560"/>
                <a:ext cx="37080" cy="324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155760" y="17751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6" name=""/>
            <p:cNvGrpSpPr/>
            <p:nvPr/>
          </p:nvGrpSpPr>
          <p:grpSpPr>
            <a:xfrm>
              <a:off x="608400" y="1947960"/>
              <a:ext cx="2576520" cy="295560"/>
              <a:chOff x="608400" y="1947960"/>
              <a:chExt cx="2576520" cy="295560"/>
            </a:xfrm>
          </p:grpSpPr>
          <p:sp>
            <p:nvSpPr>
              <p:cNvPr id="117" name=""/>
              <p:cNvSpPr/>
              <p:nvPr/>
            </p:nvSpPr>
            <p:spPr>
              <a:xfrm>
                <a:off x="608400" y="1947960"/>
                <a:ext cx="2576520" cy="295560"/>
              </a:xfrm>
              <a:custGeom>
                <a:avLst/>
                <a:gdLst/>
                <a:ahLst/>
                <a:rect l="l" t="t" r="r" b="b"/>
                <a:pathLst>
                  <a:path w="2768" h="360">
                    <a:moveTo>
                      <a:pt x="0" y="0"/>
                    </a:moveTo>
                    <a:lnTo>
                      <a:pt x="2768" y="360"/>
                    </a:lnTo>
                    <a:lnTo>
                      <a:pt x="2768" y="36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608400" y="1947960"/>
                <a:ext cx="2576520" cy="29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9" name=""/>
            <p:cNvSpPr/>
            <p:nvPr/>
          </p:nvSpPr>
          <p:spPr>
            <a:xfrm rot="16200000">
              <a:off x="-649080" y="1858680"/>
              <a:ext cx="1451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al fat oxidation (g/6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348640" y="3958560"/>
              <a:ext cx="2631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rea under glucose curve (mmol/L.360 min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7436520" y="357516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8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6773760" y="357516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6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6096600" y="357516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423040" y="357516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817520" y="3571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6" name=""/>
            <p:cNvGrpSpPr/>
            <p:nvPr/>
          </p:nvGrpSpPr>
          <p:grpSpPr>
            <a:xfrm>
              <a:off x="4833360" y="3509640"/>
              <a:ext cx="2680560" cy="27000"/>
              <a:chOff x="4833360" y="3509640"/>
              <a:chExt cx="2680560" cy="27000"/>
            </a:xfrm>
          </p:grpSpPr>
          <p:sp>
            <p:nvSpPr>
              <p:cNvPr id="127" name=""/>
              <p:cNvSpPr/>
              <p:nvPr/>
            </p:nvSpPr>
            <p:spPr>
              <a:xfrm flipV="1">
                <a:off x="4833360" y="350964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 flipV="1">
                <a:off x="5166360" y="3510000"/>
                <a:ext cx="720" cy="13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 flipV="1">
                <a:off x="5499360" y="350964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 flipV="1">
                <a:off x="5840280" y="3510000"/>
                <a:ext cx="720" cy="13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 flipV="1">
                <a:off x="6173280" y="350964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 flipV="1">
                <a:off x="6506280" y="3510000"/>
                <a:ext cx="720" cy="13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 flipV="1">
                <a:off x="6847200" y="350964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 flipV="1">
                <a:off x="7180200" y="3510000"/>
                <a:ext cx="720" cy="13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 flipV="1">
                <a:off x="7513200" y="3509640"/>
                <a:ext cx="72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4833360" y="3510000"/>
                <a:ext cx="2679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7" name=""/>
            <p:cNvGrpSpPr/>
            <p:nvPr/>
          </p:nvGrpSpPr>
          <p:grpSpPr>
            <a:xfrm>
              <a:off x="4542120" y="314280"/>
              <a:ext cx="176040" cy="3270240"/>
              <a:chOff x="4542120" y="314280"/>
              <a:chExt cx="176040" cy="3270240"/>
            </a:xfrm>
          </p:grpSpPr>
          <p:sp>
            <p:nvSpPr>
              <p:cNvPr id="138" name=""/>
              <p:cNvSpPr/>
              <p:nvPr/>
            </p:nvSpPr>
            <p:spPr>
              <a:xfrm>
                <a:off x="4542120" y="34318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542120" y="28069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4542120" y="21848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4542120" y="15631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4542120" y="9410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4542120" y="3142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79320"/>
                    <a:tab algn="l" pos="1359000"/>
                    <a:tab algn="l" pos="2038320"/>
                    <a:tab algn="l" pos="2717640"/>
                    <a:tab algn="l" pos="3397320"/>
                    <a:tab algn="l" pos="4076640"/>
                    <a:tab algn="l" pos="4756320"/>
                    <a:tab algn="l" pos="5435640"/>
                    <a:tab algn="l" pos="6114960"/>
                    <a:tab algn="l" pos="6794640"/>
                    <a:tab algn="l" pos="7473960"/>
                    <a:tab algn="l" pos="8153280"/>
                    <a:tab algn="l" pos="8832960"/>
                    <a:tab algn="l" pos="9512280"/>
                    <a:tab algn="l" pos="10191600"/>
                    <a:tab algn="l" pos="108712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4" name=""/>
            <p:cNvGrpSpPr/>
            <p:nvPr/>
          </p:nvGrpSpPr>
          <p:grpSpPr>
            <a:xfrm>
              <a:off x="4803480" y="394560"/>
              <a:ext cx="32400" cy="3115440"/>
              <a:chOff x="4803480" y="394560"/>
              <a:chExt cx="32400" cy="3115440"/>
            </a:xfrm>
          </p:grpSpPr>
          <p:sp>
            <p:nvSpPr>
              <p:cNvPr id="145" name=""/>
              <p:cNvSpPr/>
              <p:nvPr/>
            </p:nvSpPr>
            <p:spPr>
              <a:xfrm flipH="1">
                <a:off x="4803480" y="3509280"/>
                <a:ext cx="313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 flipH="1">
                <a:off x="4819320" y="319428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 flipH="1">
                <a:off x="4803480" y="2886120"/>
                <a:ext cx="313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 flipH="1">
                <a:off x="4819320" y="257148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 flipH="1">
                <a:off x="4803480" y="2263680"/>
                <a:ext cx="313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 flipH="1">
                <a:off x="4819320" y="195552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 flipH="1">
                <a:off x="4803480" y="1640520"/>
                <a:ext cx="313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 flipH="1">
                <a:off x="4819320" y="132552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 flipH="1">
                <a:off x="4803480" y="1017720"/>
                <a:ext cx="313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flipH="1">
                <a:off x="4819320" y="70272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 flipH="1">
                <a:off x="4803480" y="394920"/>
                <a:ext cx="313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 flipV="1">
                <a:off x="4835160" y="394560"/>
                <a:ext cx="720" cy="311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7" name=""/>
            <p:cNvGrpSpPr/>
            <p:nvPr/>
          </p:nvGrpSpPr>
          <p:grpSpPr>
            <a:xfrm>
              <a:off x="5004720" y="1998000"/>
              <a:ext cx="37080" cy="34200"/>
              <a:chOff x="5004720" y="1998000"/>
              <a:chExt cx="37080" cy="34200"/>
            </a:xfrm>
          </p:grpSpPr>
          <p:sp>
            <p:nvSpPr>
              <p:cNvPr id="158" name=""/>
              <p:cNvSpPr/>
              <p:nvPr/>
            </p:nvSpPr>
            <p:spPr>
              <a:xfrm>
                <a:off x="5004720" y="1998000"/>
                <a:ext cx="37080" cy="342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5019480" y="20116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0" name=""/>
            <p:cNvGrpSpPr/>
            <p:nvPr/>
          </p:nvGrpSpPr>
          <p:grpSpPr>
            <a:xfrm>
              <a:off x="5089320" y="2095560"/>
              <a:ext cx="38880" cy="34560"/>
              <a:chOff x="5089320" y="2095560"/>
              <a:chExt cx="38880" cy="34560"/>
            </a:xfrm>
          </p:grpSpPr>
          <p:sp>
            <p:nvSpPr>
              <p:cNvPr id="161" name=""/>
              <p:cNvSpPr/>
              <p:nvPr/>
            </p:nvSpPr>
            <p:spPr>
              <a:xfrm>
                <a:off x="5089320" y="2095560"/>
                <a:ext cx="38880" cy="3456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5104800" y="21092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3" name=""/>
            <p:cNvGrpSpPr/>
            <p:nvPr/>
          </p:nvGrpSpPr>
          <p:grpSpPr>
            <a:xfrm>
              <a:off x="5159880" y="2558160"/>
              <a:ext cx="37080" cy="34200"/>
              <a:chOff x="5159880" y="2558160"/>
              <a:chExt cx="37080" cy="34200"/>
            </a:xfrm>
          </p:grpSpPr>
          <p:sp>
            <p:nvSpPr>
              <p:cNvPr id="164" name=""/>
              <p:cNvSpPr/>
              <p:nvPr/>
            </p:nvSpPr>
            <p:spPr>
              <a:xfrm>
                <a:off x="5159880" y="2558160"/>
                <a:ext cx="37080" cy="342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5174640" y="25718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6" name=""/>
            <p:cNvGrpSpPr/>
            <p:nvPr/>
          </p:nvGrpSpPr>
          <p:grpSpPr>
            <a:xfrm>
              <a:off x="5306400" y="973800"/>
              <a:ext cx="38880" cy="35640"/>
              <a:chOff x="5306400" y="973800"/>
              <a:chExt cx="38880" cy="35640"/>
            </a:xfrm>
          </p:grpSpPr>
          <p:sp>
            <p:nvSpPr>
              <p:cNvPr id="167" name=""/>
              <p:cNvSpPr/>
              <p:nvPr/>
            </p:nvSpPr>
            <p:spPr>
              <a:xfrm>
                <a:off x="5306400" y="973800"/>
                <a:ext cx="38880" cy="356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5321880" y="9878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9" name=""/>
            <p:cNvGrpSpPr/>
            <p:nvPr/>
          </p:nvGrpSpPr>
          <p:grpSpPr>
            <a:xfrm>
              <a:off x="5407560" y="2558160"/>
              <a:ext cx="37080" cy="34200"/>
              <a:chOff x="5407560" y="2558160"/>
              <a:chExt cx="37080" cy="34200"/>
            </a:xfrm>
          </p:grpSpPr>
          <p:sp>
            <p:nvSpPr>
              <p:cNvPr id="170" name=""/>
              <p:cNvSpPr/>
              <p:nvPr/>
            </p:nvSpPr>
            <p:spPr>
              <a:xfrm>
                <a:off x="5407560" y="2558160"/>
                <a:ext cx="37080" cy="342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5422320" y="25718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2" name=""/>
            <p:cNvGrpSpPr/>
            <p:nvPr/>
          </p:nvGrpSpPr>
          <p:grpSpPr>
            <a:xfrm>
              <a:off x="5864760" y="2221200"/>
              <a:ext cx="38520" cy="36000"/>
              <a:chOff x="5864760" y="2221200"/>
              <a:chExt cx="38520" cy="36000"/>
            </a:xfrm>
          </p:grpSpPr>
          <p:sp>
            <p:nvSpPr>
              <p:cNvPr id="173" name=""/>
              <p:cNvSpPr/>
              <p:nvPr/>
            </p:nvSpPr>
            <p:spPr>
              <a:xfrm>
                <a:off x="5864760" y="2221200"/>
                <a:ext cx="38520" cy="360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5879880" y="22352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5" name=""/>
            <p:cNvGrpSpPr/>
            <p:nvPr/>
          </p:nvGrpSpPr>
          <p:grpSpPr>
            <a:xfrm>
              <a:off x="5926320" y="2401560"/>
              <a:ext cx="38880" cy="36000"/>
              <a:chOff x="5926320" y="2401560"/>
              <a:chExt cx="38880" cy="36000"/>
            </a:xfrm>
          </p:grpSpPr>
          <p:sp>
            <p:nvSpPr>
              <p:cNvPr id="176" name=""/>
              <p:cNvSpPr/>
              <p:nvPr/>
            </p:nvSpPr>
            <p:spPr>
              <a:xfrm>
                <a:off x="5926320" y="2401560"/>
                <a:ext cx="38880" cy="360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5941800" y="24159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8" name=""/>
            <p:cNvGrpSpPr/>
            <p:nvPr/>
          </p:nvGrpSpPr>
          <p:grpSpPr>
            <a:xfrm>
              <a:off x="6151680" y="2248920"/>
              <a:ext cx="37080" cy="34200"/>
              <a:chOff x="6151680" y="2248920"/>
              <a:chExt cx="37080" cy="34200"/>
            </a:xfrm>
          </p:grpSpPr>
          <p:sp>
            <p:nvSpPr>
              <p:cNvPr id="179" name=""/>
              <p:cNvSpPr/>
              <p:nvPr/>
            </p:nvSpPr>
            <p:spPr>
              <a:xfrm>
                <a:off x="6151680" y="2248920"/>
                <a:ext cx="37080" cy="342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6166440" y="22626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1" name=""/>
            <p:cNvGrpSpPr/>
            <p:nvPr/>
          </p:nvGrpSpPr>
          <p:grpSpPr>
            <a:xfrm>
              <a:off x="6594120" y="3243600"/>
              <a:ext cx="37080" cy="36000"/>
              <a:chOff x="6594120" y="3243600"/>
              <a:chExt cx="37080" cy="36000"/>
            </a:xfrm>
          </p:grpSpPr>
          <p:sp>
            <p:nvSpPr>
              <p:cNvPr id="182" name=""/>
              <p:cNvSpPr/>
              <p:nvPr/>
            </p:nvSpPr>
            <p:spPr>
              <a:xfrm>
                <a:off x="6594120" y="3243600"/>
                <a:ext cx="37080" cy="360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6608880" y="32580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4" name=""/>
            <p:cNvGrpSpPr/>
            <p:nvPr/>
          </p:nvGrpSpPr>
          <p:grpSpPr>
            <a:xfrm>
              <a:off x="7063920" y="2159640"/>
              <a:ext cx="38880" cy="32040"/>
              <a:chOff x="7063920" y="2159640"/>
              <a:chExt cx="38880" cy="32040"/>
            </a:xfrm>
          </p:grpSpPr>
          <p:sp>
            <p:nvSpPr>
              <p:cNvPr id="185" name=""/>
              <p:cNvSpPr/>
              <p:nvPr/>
            </p:nvSpPr>
            <p:spPr>
              <a:xfrm>
                <a:off x="7063920" y="2159640"/>
                <a:ext cx="388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7079400" y="21722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7" name=""/>
            <p:cNvGrpSpPr/>
            <p:nvPr/>
          </p:nvGrpSpPr>
          <p:grpSpPr>
            <a:xfrm>
              <a:off x="4833360" y="1977120"/>
              <a:ext cx="2679120" cy="811080"/>
              <a:chOff x="4833360" y="1977120"/>
              <a:chExt cx="2679120" cy="811080"/>
            </a:xfrm>
          </p:grpSpPr>
          <p:sp>
            <p:nvSpPr>
              <p:cNvPr id="188" name=""/>
              <p:cNvSpPr/>
              <p:nvPr/>
            </p:nvSpPr>
            <p:spPr>
              <a:xfrm>
                <a:off x="4833360" y="1977120"/>
                <a:ext cx="2679120" cy="811080"/>
              </a:xfrm>
              <a:custGeom>
                <a:avLst/>
                <a:gdLst/>
                <a:ahLst/>
                <a:rect l="l" t="t" r="r" b="b"/>
                <a:pathLst>
                  <a:path w="2768" h="928">
                    <a:moveTo>
                      <a:pt x="0" y="0"/>
                    </a:moveTo>
                    <a:lnTo>
                      <a:pt x="2768" y="928"/>
                    </a:lnTo>
                    <a:lnTo>
                      <a:pt x="2768" y="928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4833360" y="1977120"/>
                <a:ext cx="2679120" cy="811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0" name=""/>
            <p:cNvSpPr/>
            <p:nvPr/>
          </p:nvSpPr>
          <p:spPr>
            <a:xfrm rot="16200000">
              <a:off x="3581640" y="1882080"/>
              <a:ext cx="1451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679320"/>
                  <a:tab algn="l" pos="1359000"/>
                  <a:tab algn="l" pos="2038320"/>
                  <a:tab algn="l" pos="2717640"/>
                  <a:tab algn="l" pos="3397320"/>
                  <a:tab algn="l" pos="4076640"/>
                  <a:tab algn="l" pos="4756320"/>
                  <a:tab algn="l" pos="5435640"/>
                  <a:tab algn="l" pos="6114960"/>
                  <a:tab algn="l" pos="6794640"/>
                  <a:tab algn="l" pos="7473960"/>
                  <a:tab algn="l" pos="8153280"/>
                  <a:tab algn="l" pos="8832960"/>
                  <a:tab algn="l" pos="9512280"/>
                  <a:tab algn="l" pos="10191600"/>
                  <a:tab algn="l" pos="1087128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al fat oxidation (g/6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28T19:15:57Z</dcterms:created>
  <dc:creator>janine</dc:creator>
  <dc:description/>
  <dc:language>en-US</dc:language>
  <cp:lastModifiedBy>higbee</cp:lastModifiedBy>
  <dcterms:modified xsi:type="dcterms:W3CDTF">2004-10-02T00:17:26Z</dcterms:modified>
  <cp:revision>4</cp:revision>
  <dc:subject/>
  <dc:title>Slide 1</dc:title>
</cp:coreProperties>
</file>